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  <p:sldId id="26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7" y="55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81215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310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44482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75002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6451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107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67929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38338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7926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2667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0137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3618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jpg"/><Relationship Id="rId3" Type="http://schemas.openxmlformats.org/officeDocument/2006/relationships/image" Target="../media/image6.jpg"/><Relationship Id="rId7" Type="http://schemas.openxmlformats.org/officeDocument/2006/relationships/image" Target="../media/image10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jpg"/><Relationship Id="rId5" Type="http://schemas.openxmlformats.org/officeDocument/2006/relationships/image" Target="../media/image8.jpg"/><Relationship Id="rId4" Type="http://schemas.openxmlformats.org/officeDocument/2006/relationships/image" Target="../media/image7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4.jpg"/><Relationship Id="rId4" Type="http://schemas.microsoft.com/office/2007/relationships/hdphoto" Target="../media/hdphoto1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13" Type="http://schemas.openxmlformats.org/officeDocument/2006/relationships/image" Target="../media/image25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12" Type="http://schemas.openxmlformats.org/officeDocument/2006/relationships/image" Target="../media/image24.jp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Relationship Id="rId11" Type="http://schemas.openxmlformats.org/officeDocument/2006/relationships/image" Target="../media/image23.jpg"/><Relationship Id="rId5" Type="http://schemas.openxmlformats.org/officeDocument/2006/relationships/image" Target="../media/image18.png"/><Relationship Id="rId10" Type="http://schemas.microsoft.com/office/2007/relationships/hdphoto" Target="../media/hdphoto2.wdp"/><Relationship Id="rId4" Type="http://schemas.openxmlformats.org/officeDocument/2006/relationships/image" Target="../media/image17.png"/><Relationship Id="rId9" Type="http://schemas.openxmlformats.org/officeDocument/2006/relationships/image" Target="../media/image22.png"/><Relationship Id="rId14" Type="http://schemas.openxmlformats.org/officeDocument/2006/relationships/image" Target="../media/image2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png"/><Relationship Id="rId13" Type="http://schemas.openxmlformats.org/officeDocument/2006/relationships/image" Target="../media/image38.png"/><Relationship Id="rId3" Type="http://schemas.openxmlformats.org/officeDocument/2006/relationships/image" Target="../media/image28.png"/><Relationship Id="rId7" Type="http://schemas.openxmlformats.org/officeDocument/2006/relationships/image" Target="../media/image32.png"/><Relationship Id="rId12" Type="http://schemas.openxmlformats.org/officeDocument/2006/relationships/image" Target="../media/image37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png"/><Relationship Id="rId11" Type="http://schemas.openxmlformats.org/officeDocument/2006/relationships/image" Target="../media/image36.png"/><Relationship Id="rId5" Type="http://schemas.openxmlformats.org/officeDocument/2006/relationships/image" Target="../media/image30.png"/><Relationship Id="rId10" Type="http://schemas.openxmlformats.org/officeDocument/2006/relationships/image" Target="../media/image35.png"/><Relationship Id="rId4" Type="http://schemas.openxmlformats.org/officeDocument/2006/relationships/image" Target="../media/image29.png"/><Relationship Id="rId9" Type="http://schemas.openxmlformats.org/officeDocument/2006/relationships/image" Target="../media/image3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Box 38"/>
          <p:cNvSpPr txBox="1"/>
          <p:nvPr/>
        </p:nvSpPr>
        <p:spPr>
          <a:xfrm>
            <a:off x="1180274" y="1654606"/>
            <a:ext cx="16881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AM210A-FLAG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4424685" y="1645233"/>
            <a:ext cx="7184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EFTU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6942043" y="1645233"/>
            <a:ext cx="12009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totracker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>
            <a:grpSpLocks noChangeAspect="1"/>
          </p:cNvGrpSpPr>
          <p:nvPr/>
        </p:nvGrpSpPr>
        <p:grpSpPr>
          <a:xfrm>
            <a:off x="6238315" y="2005079"/>
            <a:ext cx="2761397" cy="2743200"/>
            <a:chOff x="4842303" y="3066473"/>
            <a:chExt cx="1840931" cy="1828800"/>
          </a:xfrm>
        </p:grpSpPr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42303" y="3066473"/>
              <a:ext cx="1840931" cy="1828800"/>
            </a:xfrm>
            <a:prstGeom prst="rect">
              <a:avLst/>
            </a:prstGeom>
          </p:spPr>
        </p:pic>
        <p:cxnSp>
          <p:nvCxnSpPr>
            <p:cNvPr id="47" name="Straight Connector 46"/>
            <p:cNvCxnSpPr/>
            <p:nvPr/>
          </p:nvCxnSpPr>
          <p:spPr>
            <a:xfrm flipV="1">
              <a:off x="6201093" y="4801426"/>
              <a:ext cx="458086" cy="3628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1" name="Group 50"/>
          <p:cNvGrpSpPr>
            <a:grpSpLocks noChangeAspect="1"/>
          </p:cNvGrpSpPr>
          <p:nvPr/>
        </p:nvGrpSpPr>
        <p:grpSpPr>
          <a:xfrm>
            <a:off x="3403220" y="1993160"/>
            <a:ext cx="2761397" cy="2743200"/>
            <a:chOff x="2968905" y="3075709"/>
            <a:chExt cx="1840931" cy="1828800"/>
          </a:xfrm>
        </p:grpSpPr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68905" y="3075709"/>
              <a:ext cx="1840931" cy="1828800"/>
            </a:xfrm>
            <a:prstGeom prst="rect">
              <a:avLst/>
            </a:prstGeom>
          </p:spPr>
        </p:pic>
        <p:cxnSp>
          <p:nvCxnSpPr>
            <p:cNvPr id="48" name="Straight Connector 47"/>
            <p:cNvCxnSpPr/>
            <p:nvPr/>
          </p:nvCxnSpPr>
          <p:spPr>
            <a:xfrm flipV="1">
              <a:off x="4333404" y="4797798"/>
              <a:ext cx="458086" cy="3628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2" name="Group 51"/>
          <p:cNvGrpSpPr>
            <a:grpSpLocks noChangeAspect="1"/>
          </p:cNvGrpSpPr>
          <p:nvPr/>
        </p:nvGrpSpPr>
        <p:grpSpPr>
          <a:xfrm>
            <a:off x="557438" y="1993160"/>
            <a:ext cx="2772084" cy="2743200"/>
            <a:chOff x="1095507" y="3075709"/>
            <a:chExt cx="1848056" cy="1828800"/>
          </a:xfrm>
        </p:grpSpPr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95507" y="3075709"/>
              <a:ext cx="1840931" cy="1828800"/>
            </a:xfrm>
            <a:prstGeom prst="rect">
              <a:avLst/>
            </a:prstGeom>
          </p:spPr>
        </p:pic>
        <p:cxnSp>
          <p:nvCxnSpPr>
            <p:cNvPr id="49" name="Straight Connector 48"/>
            <p:cNvCxnSpPr/>
            <p:nvPr/>
          </p:nvCxnSpPr>
          <p:spPr>
            <a:xfrm flipV="1">
              <a:off x="2485477" y="4797798"/>
              <a:ext cx="458086" cy="3628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" name="Group 1"/>
          <p:cNvGrpSpPr>
            <a:grpSpLocks noChangeAspect="1"/>
          </p:cNvGrpSpPr>
          <p:nvPr/>
        </p:nvGrpSpPr>
        <p:grpSpPr>
          <a:xfrm>
            <a:off x="9073410" y="2005079"/>
            <a:ext cx="2761397" cy="2743200"/>
            <a:chOff x="6748168" y="3066473"/>
            <a:chExt cx="1840931" cy="1828800"/>
          </a:xfrm>
        </p:grpSpPr>
        <p:grpSp>
          <p:nvGrpSpPr>
            <p:cNvPr id="43" name="Group 42"/>
            <p:cNvGrpSpPr/>
            <p:nvPr/>
          </p:nvGrpSpPr>
          <p:grpSpPr>
            <a:xfrm>
              <a:off x="6748168" y="3066473"/>
              <a:ext cx="1840931" cy="1828800"/>
              <a:chOff x="6748168" y="3066473"/>
              <a:chExt cx="1840931" cy="1828800"/>
            </a:xfrm>
          </p:grpSpPr>
          <p:pic>
            <p:nvPicPr>
              <p:cNvPr id="44" name="Picture 43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48168" y="3066473"/>
                <a:ext cx="1840931" cy="1828800"/>
              </a:xfrm>
              <a:prstGeom prst="rect">
                <a:avLst/>
              </a:prstGeom>
            </p:spPr>
          </p:pic>
          <p:cxnSp>
            <p:nvCxnSpPr>
              <p:cNvPr id="45" name="Straight Connector 44"/>
              <p:cNvCxnSpPr/>
              <p:nvPr/>
            </p:nvCxnSpPr>
            <p:spPr>
              <a:xfrm>
                <a:off x="7205133" y="4576233"/>
                <a:ext cx="258234" cy="194734"/>
              </a:xfrm>
              <a:prstGeom prst="line">
                <a:avLst/>
              </a:prstGeom>
              <a:ln w="12700">
                <a:solidFill>
                  <a:srgbClr val="FF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6" name="Straight Connector 45"/>
            <p:cNvCxnSpPr/>
            <p:nvPr/>
          </p:nvCxnSpPr>
          <p:spPr>
            <a:xfrm flipV="1">
              <a:off x="8081881" y="4770967"/>
              <a:ext cx="458086" cy="3628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49"/>
            <p:cNvSpPr txBox="1"/>
            <p:nvPr/>
          </p:nvSpPr>
          <p:spPr>
            <a:xfrm>
              <a:off x="8116655" y="4576233"/>
              <a:ext cx="423312" cy="205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r>
                <a:rPr lang="el-GR" sz="14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14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3" name="TextBox 52"/>
          <p:cNvSpPr txBox="1"/>
          <p:nvPr/>
        </p:nvSpPr>
        <p:spPr>
          <a:xfrm>
            <a:off x="9983192" y="1644229"/>
            <a:ext cx="7665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4"/>
          <p:cNvSpPr txBox="1"/>
          <p:nvPr/>
        </p:nvSpPr>
        <p:spPr>
          <a:xfrm>
            <a:off x="5143151" y="322025"/>
            <a:ext cx="16879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7C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76026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70" t="36391" r="29367" b="45765"/>
          <a:stretch/>
        </p:blipFill>
        <p:spPr>
          <a:xfrm>
            <a:off x="7410821" y="1361084"/>
            <a:ext cx="3898232" cy="1223785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289" t="9422" r="23266" b="72760"/>
          <a:stretch/>
        </p:blipFill>
        <p:spPr>
          <a:xfrm>
            <a:off x="3675348" y="1605917"/>
            <a:ext cx="2353056" cy="1222009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84" t="8711" r="22555" b="73370"/>
          <a:stretch/>
        </p:blipFill>
        <p:spPr>
          <a:xfrm>
            <a:off x="1176198" y="1526394"/>
            <a:ext cx="2328672" cy="1228891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270831" y="2440418"/>
            <a:ext cx="649536" cy="2091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4556199" y="2513571"/>
            <a:ext cx="882615" cy="24171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602601" y="2359682"/>
            <a:ext cx="6527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FTU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200882" y="233812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201607" y="204379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 rot="18590147">
            <a:off x="4951865" y="1842696"/>
            <a:ext cx="9714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AM210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8235114">
            <a:off x="4523613" y="2034928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487131" y="6008774"/>
            <a:ext cx="24492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7D left panel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226580" y="2800955"/>
            <a:ext cx="13981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hort exposure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270831" y="2071086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put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904853" y="2870957"/>
            <a:ext cx="13676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Long exposure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923279" y="233812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902694" y="2049216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760216" y="1250297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Straight Connector 30"/>
          <p:cNvCxnSpPr/>
          <p:nvPr/>
        </p:nvCxnSpPr>
        <p:spPr>
          <a:xfrm>
            <a:off x="4541801" y="1546477"/>
            <a:ext cx="126418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3808605" y="2140839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put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Picture 32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289" t="35022" r="25815" b="42045"/>
          <a:stretch/>
        </p:blipFill>
        <p:spPr>
          <a:xfrm flipH="1">
            <a:off x="1270831" y="3925527"/>
            <a:ext cx="2133600" cy="1572768"/>
          </a:xfrm>
          <a:prstGeom prst="rect">
            <a:avLst/>
          </a:prstGeom>
        </p:spPr>
      </p:pic>
      <p:sp>
        <p:nvSpPr>
          <p:cNvPr id="34" name="Rectangle 33"/>
          <p:cNvSpPr/>
          <p:nvPr/>
        </p:nvSpPr>
        <p:spPr>
          <a:xfrm>
            <a:off x="1432451" y="4698952"/>
            <a:ext cx="649536" cy="2091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Box 34"/>
          <p:cNvSpPr txBox="1"/>
          <p:nvPr/>
        </p:nvSpPr>
        <p:spPr>
          <a:xfrm>
            <a:off x="1376345" y="4340529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Input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829232" y="1619629"/>
            <a:ext cx="10244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AM210A-FLAG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567543" y="5564961"/>
            <a:ext cx="13676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Long exposure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Picture 37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00" t="35200" r="26242" b="43644"/>
          <a:stretch/>
        </p:blipFill>
        <p:spPr>
          <a:xfrm flipH="1">
            <a:off x="3798376" y="3868123"/>
            <a:ext cx="2287720" cy="1630172"/>
          </a:xfrm>
          <a:prstGeom prst="rect">
            <a:avLst/>
          </a:prstGeom>
        </p:spPr>
      </p:pic>
      <p:sp>
        <p:nvSpPr>
          <p:cNvPr id="39" name="Rectangle 38"/>
          <p:cNvSpPr/>
          <p:nvPr/>
        </p:nvSpPr>
        <p:spPr>
          <a:xfrm>
            <a:off x="4704045" y="4709861"/>
            <a:ext cx="987125" cy="27650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TextBox 39"/>
          <p:cNvSpPr txBox="1"/>
          <p:nvPr/>
        </p:nvSpPr>
        <p:spPr>
          <a:xfrm rot="18590147">
            <a:off x="5160972" y="4218279"/>
            <a:ext cx="9714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AM210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 rot="18235114">
            <a:off x="4773152" y="4364476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6085291" y="463460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6033380" y="426526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5173892" y="3648966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Straight Connector 44"/>
          <p:cNvCxnSpPr/>
          <p:nvPr/>
        </p:nvCxnSpPr>
        <p:spPr>
          <a:xfrm>
            <a:off x="4760215" y="4052566"/>
            <a:ext cx="126418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4137973" y="5498295"/>
            <a:ext cx="13981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hort exposure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3347569" y="459686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3347569" y="4249520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6076044" y="514901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3361169" y="506158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903767" y="4340529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Input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11240431" y="1764867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11240431" y="1534868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ctangle 53"/>
          <p:cNvSpPr/>
          <p:nvPr/>
        </p:nvSpPr>
        <p:spPr>
          <a:xfrm>
            <a:off x="7894373" y="1682760"/>
            <a:ext cx="544633" cy="17915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TextBox 54"/>
          <p:cNvSpPr txBox="1"/>
          <p:nvPr/>
        </p:nvSpPr>
        <p:spPr>
          <a:xfrm>
            <a:off x="7835329" y="1403077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put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tangle 55"/>
          <p:cNvSpPr/>
          <p:nvPr/>
        </p:nvSpPr>
        <p:spPr>
          <a:xfrm>
            <a:off x="9058518" y="1682495"/>
            <a:ext cx="750468" cy="17194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TextBox 56"/>
          <p:cNvSpPr txBox="1"/>
          <p:nvPr/>
        </p:nvSpPr>
        <p:spPr>
          <a:xfrm rot="18235114">
            <a:off x="8996065" y="1292140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 rot="18235114">
            <a:off x="9314380" y="1207196"/>
            <a:ext cx="6527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9298923" y="815416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Straight Connector 59"/>
          <p:cNvCxnSpPr/>
          <p:nvPr/>
        </p:nvCxnSpPr>
        <p:spPr>
          <a:xfrm>
            <a:off x="9141018" y="1116432"/>
            <a:ext cx="6703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49" t="55539" r="29527" b="27919"/>
          <a:stretch/>
        </p:blipFill>
        <p:spPr>
          <a:xfrm flipH="1">
            <a:off x="7497999" y="3129104"/>
            <a:ext cx="3911982" cy="1134406"/>
          </a:xfrm>
          <a:prstGeom prst="rect">
            <a:avLst/>
          </a:prstGeom>
        </p:spPr>
      </p:pic>
      <p:sp>
        <p:nvSpPr>
          <p:cNvPr id="61" name="TextBox 60"/>
          <p:cNvSpPr txBox="1"/>
          <p:nvPr/>
        </p:nvSpPr>
        <p:spPr>
          <a:xfrm>
            <a:off x="11362897" y="354684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11342312" y="325793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11383482" y="3829820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5914577" y="1864550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11271780" y="3075378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Rectangle 65"/>
          <p:cNvSpPr/>
          <p:nvPr/>
        </p:nvSpPr>
        <p:spPr>
          <a:xfrm>
            <a:off x="9059384" y="3645745"/>
            <a:ext cx="750468" cy="17194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TextBox 66"/>
          <p:cNvSpPr txBox="1"/>
          <p:nvPr/>
        </p:nvSpPr>
        <p:spPr>
          <a:xfrm rot="18235114">
            <a:off x="8996931" y="3255390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 rot="18235114">
            <a:off x="9315246" y="3170446"/>
            <a:ext cx="6527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9299789" y="2778666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Straight Connector 69"/>
          <p:cNvCxnSpPr/>
          <p:nvPr/>
        </p:nvCxnSpPr>
        <p:spPr>
          <a:xfrm>
            <a:off x="9141884" y="3079682"/>
            <a:ext cx="6703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7124722" y="3557882"/>
            <a:ext cx="6527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FTU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8857966" y="4043792"/>
            <a:ext cx="13676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Long exposure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70" t="54536" r="29446" b="27920"/>
          <a:stretch/>
        </p:blipFill>
        <p:spPr>
          <a:xfrm flipH="1">
            <a:off x="7487300" y="4392340"/>
            <a:ext cx="3891358" cy="1203158"/>
          </a:xfrm>
          <a:prstGeom prst="rect">
            <a:avLst/>
          </a:prstGeom>
        </p:spPr>
      </p:pic>
      <p:sp>
        <p:nvSpPr>
          <p:cNvPr id="73" name="TextBox 72"/>
          <p:cNvSpPr txBox="1"/>
          <p:nvPr/>
        </p:nvSpPr>
        <p:spPr>
          <a:xfrm>
            <a:off x="8733909" y="5570439"/>
            <a:ext cx="13981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hort exposure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7207943" y="4897049"/>
            <a:ext cx="6527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FTU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Rectangle 77"/>
          <p:cNvSpPr/>
          <p:nvPr/>
        </p:nvSpPr>
        <p:spPr>
          <a:xfrm>
            <a:off x="7893370" y="4955209"/>
            <a:ext cx="439357" cy="1569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TextBox 78"/>
          <p:cNvSpPr txBox="1"/>
          <p:nvPr/>
        </p:nvSpPr>
        <p:spPr>
          <a:xfrm>
            <a:off x="7799951" y="4668651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put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11341074" y="486015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11320489" y="457125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11361659" y="514313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11262273" y="4430373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8280458" y="6008774"/>
            <a:ext cx="2393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7D right panel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24"/>
          <p:cNvSpPr txBox="1"/>
          <p:nvPr/>
        </p:nvSpPr>
        <p:spPr>
          <a:xfrm>
            <a:off x="5115696" y="162712"/>
            <a:ext cx="16879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7D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282794" y="4634601"/>
            <a:ext cx="10244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AM210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9645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60" t="67527" r="28373" b="19337"/>
          <a:stretch/>
        </p:blipFill>
        <p:spPr>
          <a:xfrm>
            <a:off x="4396415" y="1571037"/>
            <a:ext cx="3232726" cy="79432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366" t="52329" r="29166" b="31786"/>
          <a:stretch/>
        </p:blipFill>
        <p:spPr>
          <a:xfrm>
            <a:off x="4396415" y="2476200"/>
            <a:ext cx="3241519" cy="104371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4851108" y="1589509"/>
            <a:ext cx="1300215" cy="2401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6151323" y="1598745"/>
            <a:ext cx="1108363" cy="2401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3624543" y="1589509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022259" y="1263258"/>
            <a:ext cx="582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230314" y="1270093"/>
            <a:ext cx="9220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P: FLAG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4676731" y="2747032"/>
            <a:ext cx="1299101" cy="51097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5975832" y="2756268"/>
            <a:ext cx="1271915" cy="5017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/>
          <p:cNvSpPr txBox="1"/>
          <p:nvPr/>
        </p:nvSpPr>
        <p:spPr>
          <a:xfrm>
            <a:off x="4847882" y="2420781"/>
            <a:ext cx="582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151323" y="2393073"/>
            <a:ext cx="9220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P: FLAG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789890" y="2844166"/>
            <a:ext cx="6527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938969" y="1196220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B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298" t="18446" r="32088" b="71128"/>
          <a:stretch/>
        </p:blipFill>
        <p:spPr>
          <a:xfrm>
            <a:off x="4396415" y="3727328"/>
            <a:ext cx="3224464" cy="715020"/>
          </a:xfrm>
          <a:prstGeom prst="rect">
            <a:avLst/>
          </a:prstGeom>
        </p:spPr>
      </p:pic>
      <p:sp>
        <p:nvSpPr>
          <p:cNvPr id="23" name="Rectangle 22"/>
          <p:cNvSpPr/>
          <p:nvPr/>
        </p:nvSpPr>
        <p:spPr>
          <a:xfrm>
            <a:off x="4676731" y="4012204"/>
            <a:ext cx="1412715" cy="2401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6089446" y="4021440"/>
            <a:ext cx="1279618" cy="2401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Box 24"/>
          <p:cNvSpPr txBox="1"/>
          <p:nvPr/>
        </p:nvSpPr>
        <p:spPr>
          <a:xfrm>
            <a:off x="4960382" y="3685953"/>
            <a:ext cx="582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6263823" y="3706370"/>
            <a:ext cx="9220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P: FLAG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743672" y="3987624"/>
            <a:ext cx="6527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FTU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383088" y="4442348"/>
            <a:ext cx="13981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hort exposure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7584920" y="414151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7579147" y="393246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7573416" y="372732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Picture 3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217" t="18647" r="31687" b="71227"/>
          <a:stretch/>
        </p:blipFill>
        <p:spPr>
          <a:xfrm>
            <a:off x="4355164" y="4763115"/>
            <a:ext cx="3265715" cy="694395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>
            <a:off x="5467482" y="5470500"/>
            <a:ext cx="13676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Long exposure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4665227" y="5065152"/>
            <a:ext cx="1412715" cy="2401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/>
          <p:cNvSpPr/>
          <p:nvPr/>
        </p:nvSpPr>
        <p:spPr>
          <a:xfrm>
            <a:off x="6077942" y="5074388"/>
            <a:ext cx="1279618" cy="2401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TextBox 35"/>
          <p:cNvSpPr txBox="1"/>
          <p:nvPr/>
        </p:nvSpPr>
        <p:spPr>
          <a:xfrm>
            <a:off x="4948878" y="4738901"/>
            <a:ext cx="582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6252319" y="4759318"/>
            <a:ext cx="9220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P: FLAG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789889" y="5006758"/>
            <a:ext cx="6527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FTU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7573416" y="5194460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7567643" y="498541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7561912" y="4780276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24"/>
          <p:cNvSpPr txBox="1"/>
          <p:nvPr/>
        </p:nvSpPr>
        <p:spPr>
          <a:xfrm>
            <a:off x="5115696" y="162712"/>
            <a:ext cx="16879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7E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03804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31797" y="1662743"/>
            <a:ext cx="3214000" cy="749754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l="-696" r="-1"/>
          <a:stretch/>
        </p:blipFill>
        <p:spPr>
          <a:xfrm>
            <a:off x="2831797" y="868097"/>
            <a:ext cx="3115377" cy="732188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4525182" y="990648"/>
            <a:ext cx="826203" cy="3040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TextBox 42"/>
          <p:cNvSpPr txBox="1"/>
          <p:nvPr/>
        </p:nvSpPr>
        <p:spPr>
          <a:xfrm>
            <a:off x="2049017" y="1075462"/>
            <a:ext cx="9028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DUFS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4495359" y="1996668"/>
            <a:ext cx="858615" cy="18778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TextBox 44"/>
          <p:cNvSpPr txBox="1"/>
          <p:nvPr/>
        </p:nvSpPr>
        <p:spPr>
          <a:xfrm>
            <a:off x="2382165" y="1914568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D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02128" y="2469243"/>
            <a:ext cx="3328273" cy="1074218"/>
          </a:xfrm>
          <a:prstGeom prst="rect">
            <a:avLst/>
          </a:prstGeom>
        </p:spPr>
      </p:pic>
      <p:sp>
        <p:nvSpPr>
          <p:cNvPr id="46" name="TextBox 45"/>
          <p:cNvSpPr txBox="1"/>
          <p:nvPr/>
        </p:nvSpPr>
        <p:spPr>
          <a:xfrm>
            <a:off x="7128546" y="2895186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OX4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8116896" y="3064257"/>
            <a:ext cx="738740" cy="28719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802128" y="3611962"/>
            <a:ext cx="3328273" cy="928001"/>
          </a:xfrm>
          <a:prstGeom prst="rect">
            <a:avLst/>
          </a:prstGeom>
        </p:spPr>
      </p:pic>
      <p:sp>
        <p:nvSpPr>
          <p:cNvPr id="48" name="Rectangle 47"/>
          <p:cNvSpPr/>
          <p:nvPr/>
        </p:nvSpPr>
        <p:spPr>
          <a:xfrm>
            <a:off x="7930177" y="3948020"/>
            <a:ext cx="730409" cy="3314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TextBox 48"/>
          <p:cNvSpPr txBox="1"/>
          <p:nvPr/>
        </p:nvSpPr>
        <p:spPr>
          <a:xfrm>
            <a:off x="7154569" y="3971679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OX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802128" y="1389001"/>
            <a:ext cx="3328273" cy="1044304"/>
          </a:xfrm>
          <a:prstGeom prst="rect">
            <a:avLst/>
          </a:prstGeom>
        </p:spPr>
      </p:pic>
      <p:sp>
        <p:nvSpPr>
          <p:cNvPr id="50" name="TextBox 49"/>
          <p:cNvSpPr txBox="1"/>
          <p:nvPr/>
        </p:nvSpPr>
        <p:spPr>
          <a:xfrm>
            <a:off x="6965671" y="1806996"/>
            <a:ext cx="862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T-CYB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50"/>
          <p:cNvSpPr/>
          <p:nvPr/>
        </p:nvSpPr>
        <p:spPr>
          <a:xfrm>
            <a:off x="7900751" y="1878397"/>
            <a:ext cx="794540" cy="30605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31797" y="5355960"/>
            <a:ext cx="3310956" cy="861976"/>
          </a:xfrm>
          <a:prstGeom prst="rect">
            <a:avLst/>
          </a:prstGeom>
        </p:spPr>
      </p:pic>
      <p:sp>
        <p:nvSpPr>
          <p:cNvPr id="52" name="Rectangle 51"/>
          <p:cNvSpPr/>
          <p:nvPr/>
        </p:nvSpPr>
        <p:spPr>
          <a:xfrm>
            <a:off x="3232942" y="5709383"/>
            <a:ext cx="739279" cy="2676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TextBox 52"/>
          <p:cNvSpPr txBox="1"/>
          <p:nvPr/>
        </p:nvSpPr>
        <p:spPr>
          <a:xfrm>
            <a:off x="1988740" y="5787274"/>
            <a:ext cx="7777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OM2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4" name="Picture 5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802128" y="826730"/>
            <a:ext cx="3328273" cy="497464"/>
          </a:xfrm>
          <a:prstGeom prst="rect">
            <a:avLst/>
          </a:prstGeom>
        </p:spPr>
      </p:pic>
      <p:sp>
        <p:nvSpPr>
          <p:cNvPr id="55" name="TextBox 54"/>
          <p:cNvSpPr txBox="1"/>
          <p:nvPr/>
        </p:nvSpPr>
        <p:spPr>
          <a:xfrm>
            <a:off x="6859241" y="921573"/>
            <a:ext cx="9428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UQCRC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tangle 55"/>
          <p:cNvSpPr/>
          <p:nvPr/>
        </p:nvSpPr>
        <p:spPr>
          <a:xfrm>
            <a:off x="8220590" y="986947"/>
            <a:ext cx="796480" cy="2629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7" name="Picture 56"/>
          <p:cNvPicPr>
            <a:picLocks noChangeAspect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992" t="45374" r="31929" b="43079"/>
          <a:stretch/>
        </p:blipFill>
        <p:spPr>
          <a:xfrm>
            <a:off x="2847966" y="2495968"/>
            <a:ext cx="3301977" cy="869487"/>
          </a:xfrm>
          <a:prstGeom prst="rect">
            <a:avLst/>
          </a:prstGeom>
        </p:spPr>
      </p:pic>
      <p:sp>
        <p:nvSpPr>
          <p:cNvPr id="58" name="TextBox 57"/>
          <p:cNvSpPr txBox="1"/>
          <p:nvPr/>
        </p:nvSpPr>
        <p:spPr>
          <a:xfrm>
            <a:off x="2213634" y="2765618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DH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tangle 58"/>
          <p:cNvSpPr/>
          <p:nvPr/>
        </p:nvSpPr>
        <p:spPr>
          <a:xfrm>
            <a:off x="3232943" y="3025644"/>
            <a:ext cx="832752" cy="2185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TextBox 59"/>
          <p:cNvSpPr txBox="1"/>
          <p:nvPr/>
        </p:nvSpPr>
        <p:spPr>
          <a:xfrm>
            <a:off x="5920649" y="283788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5897481" y="2688528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5897481" y="2506786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4" name="Picture 63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871" t="63231" r="31490" b="22473"/>
          <a:stretch/>
        </p:blipFill>
        <p:spPr>
          <a:xfrm>
            <a:off x="2814480" y="4197123"/>
            <a:ext cx="3328273" cy="1098859"/>
          </a:xfrm>
          <a:prstGeom prst="rect">
            <a:avLst/>
          </a:prstGeom>
        </p:spPr>
      </p:pic>
      <p:sp>
        <p:nvSpPr>
          <p:cNvPr id="68" name="TextBox 67"/>
          <p:cNvSpPr txBox="1"/>
          <p:nvPr/>
        </p:nvSpPr>
        <p:spPr>
          <a:xfrm>
            <a:off x="1930637" y="4602095"/>
            <a:ext cx="9714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AM210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Rectangle 68"/>
          <p:cNvSpPr/>
          <p:nvPr/>
        </p:nvSpPr>
        <p:spPr>
          <a:xfrm>
            <a:off x="3138675" y="4753456"/>
            <a:ext cx="928758" cy="2243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TextBox 69"/>
          <p:cNvSpPr txBox="1"/>
          <p:nvPr/>
        </p:nvSpPr>
        <p:spPr>
          <a:xfrm>
            <a:off x="5959096" y="421427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5953162" y="449184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5959096" y="4816780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3" name="Picture 72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92" t="19657" r="30280" b="72508"/>
          <a:stretch/>
        </p:blipFill>
        <p:spPr>
          <a:xfrm>
            <a:off x="2847966" y="3477569"/>
            <a:ext cx="3294787" cy="579639"/>
          </a:xfrm>
          <a:prstGeom prst="rect">
            <a:avLst/>
          </a:prstGeom>
        </p:spPr>
      </p:pic>
      <p:sp>
        <p:nvSpPr>
          <p:cNvPr id="74" name="TextBox 73"/>
          <p:cNvSpPr txBox="1"/>
          <p:nvPr/>
        </p:nvSpPr>
        <p:spPr>
          <a:xfrm>
            <a:off x="2111867" y="3603814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Rectangle 74"/>
          <p:cNvSpPr/>
          <p:nvPr/>
        </p:nvSpPr>
        <p:spPr>
          <a:xfrm>
            <a:off x="3138675" y="3583189"/>
            <a:ext cx="927020" cy="2957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TextBox 75"/>
          <p:cNvSpPr txBox="1"/>
          <p:nvPr/>
        </p:nvSpPr>
        <p:spPr>
          <a:xfrm>
            <a:off x="5947174" y="349266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7" name="Picture 76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893361" y="5693012"/>
            <a:ext cx="3480733" cy="987442"/>
          </a:xfrm>
          <a:prstGeom prst="rect">
            <a:avLst/>
          </a:prstGeom>
        </p:spPr>
      </p:pic>
      <p:sp>
        <p:nvSpPr>
          <p:cNvPr id="78" name="Rectangle 77"/>
          <p:cNvSpPr/>
          <p:nvPr/>
        </p:nvSpPr>
        <p:spPr>
          <a:xfrm>
            <a:off x="8893233" y="5987885"/>
            <a:ext cx="730409" cy="3314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TextBox 78"/>
          <p:cNvSpPr txBox="1"/>
          <p:nvPr/>
        </p:nvSpPr>
        <p:spPr>
          <a:xfrm>
            <a:off x="6965671" y="6032844"/>
            <a:ext cx="9276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T-ATP6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0" name="Picture 79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828151" y="4593859"/>
            <a:ext cx="3354733" cy="1032882"/>
          </a:xfrm>
          <a:prstGeom prst="rect">
            <a:avLst/>
          </a:prstGeom>
        </p:spPr>
      </p:pic>
      <p:sp>
        <p:nvSpPr>
          <p:cNvPr id="82" name="Rectangle 81"/>
          <p:cNvSpPr/>
          <p:nvPr/>
        </p:nvSpPr>
        <p:spPr>
          <a:xfrm>
            <a:off x="7924426" y="4901554"/>
            <a:ext cx="875435" cy="3314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TextBox 82"/>
          <p:cNvSpPr txBox="1"/>
          <p:nvPr/>
        </p:nvSpPr>
        <p:spPr>
          <a:xfrm>
            <a:off x="7087756" y="4944620"/>
            <a:ext cx="7403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TP5B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1" name="Group 110"/>
          <p:cNvGrpSpPr/>
          <p:nvPr/>
        </p:nvGrpSpPr>
        <p:grpSpPr>
          <a:xfrm>
            <a:off x="3173448" y="6255949"/>
            <a:ext cx="1358984" cy="529328"/>
            <a:chOff x="2115841" y="6022301"/>
            <a:chExt cx="1358984" cy="529328"/>
          </a:xfrm>
        </p:grpSpPr>
        <p:sp>
          <p:nvSpPr>
            <p:cNvPr id="108" name="Rectangle 107"/>
            <p:cNvSpPr/>
            <p:nvPr/>
          </p:nvSpPr>
          <p:spPr>
            <a:xfrm>
              <a:off x="2179034" y="6022301"/>
              <a:ext cx="1216057" cy="52932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2115841" y="6143944"/>
              <a:ext cx="5026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 rot="21533104">
              <a:off x="2535144" y="6024473"/>
              <a:ext cx="93968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am210a</a:t>
              </a:r>
            </a:p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2" name="TextBox 111"/>
          <p:cNvSpPr txBox="1"/>
          <p:nvPr/>
        </p:nvSpPr>
        <p:spPr>
          <a:xfrm rot="21533104">
            <a:off x="1730067" y="6391369"/>
            <a:ext cx="1418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ample loading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24"/>
          <p:cNvSpPr txBox="1"/>
          <p:nvPr/>
        </p:nvSpPr>
        <p:spPr>
          <a:xfrm>
            <a:off x="5115696" y="162712"/>
            <a:ext cx="16879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7F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78770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92543" y="3030131"/>
            <a:ext cx="3309862" cy="889434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73760" y="1801919"/>
            <a:ext cx="3274782" cy="644687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86436" y="2486700"/>
            <a:ext cx="3227252" cy="854981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608614" y="5073863"/>
            <a:ext cx="3311081" cy="602364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608614" y="3422181"/>
            <a:ext cx="3272400" cy="572223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7"/>
          <a:srcRect b="20275"/>
          <a:stretch/>
        </p:blipFill>
        <p:spPr>
          <a:xfrm>
            <a:off x="2892543" y="1538006"/>
            <a:ext cx="3309862" cy="472619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8"/>
          <a:srcRect t="15542"/>
          <a:stretch/>
        </p:blipFill>
        <p:spPr>
          <a:xfrm>
            <a:off x="2900804" y="798552"/>
            <a:ext cx="3302250" cy="699796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flipH="1">
            <a:off x="7586436" y="1069143"/>
            <a:ext cx="3262106" cy="67121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859374" y="4917481"/>
            <a:ext cx="3302250" cy="97947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608614" y="4054376"/>
            <a:ext cx="3275515" cy="91825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870491" y="3936707"/>
            <a:ext cx="3302250" cy="93902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900804" y="2064084"/>
            <a:ext cx="3302250" cy="929135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3882401" y="1101984"/>
            <a:ext cx="826203" cy="3040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TextBox 42"/>
          <p:cNvSpPr txBox="1"/>
          <p:nvPr/>
        </p:nvSpPr>
        <p:spPr>
          <a:xfrm>
            <a:off x="2027657" y="998947"/>
            <a:ext cx="9028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DUFS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3017530" y="1780031"/>
            <a:ext cx="858615" cy="18778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TextBox 44"/>
          <p:cNvSpPr txBox="1"/>
          <p:nvPr/>
        </p:nvSpPr>
        <p:spPr>
          <a:xfrm>
            <a:off x="2410618" y="1591465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D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6912854" y="2803934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OX4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7722386" y="2963288"/>
            <a:ext cx="738740" cy="2129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Rectangle 47"/>
          <p:cNvSpPr/>
          <p:nvPr/>
        </p:nvSpPr>
        <p:spPr>
          <a:xfrm>
            <a:off x="7748944" y="3529908"/>
            <a:ext cx="730409" cy="3314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TextBox 48"/>
          <p:cNvSpPr txBox="1"/>
          <p:nvPr/>
        </p:nvSpPr>
        <p:spPr>
          <a:xfrm>
            <a:off x="6926201" y="3544140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OX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6737303" y="1907240"/>
            <a:ext cx="862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T-CYB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50"/>
          <p:cNvSpPr/>
          <p:nvPr/>
        </p:nvSpPr>
        <p:spPr>
          <a:xfrm>
            <a:off x="8363942" y="2034966"/>
            <a:ext cx="794540" cy="30605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ectangle 51"/>
          <p:cNvSpPr/>
          <p:nvPr/>
        </p:nvSpPr>
        <p:spPr>
          <a:xfrm>
            <a:off x="3830343" y="5452518"/>
            <a:ext cx="739279" cy="2676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TextBox 52"/>
          <p:cNvSpPr txBox="1"/>
          <p:nvPr/>
        </p:nvSpPr>
        <p:spPr>
          <a:xfrm>
            <a:off x="2003880" y="5165513"/>
            <a:ext cx="7777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OM2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6643549" y="1257711"/>
            <a:ext cx="9428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UQCRC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tangle 55"/>
          <p:cNvSpPr/>
          <p:nvPr/>
        </p:nvSpPr>
        <p:spPr>
          <a:xfrm>
            <a:off x="9371685" y="1273282"/>
            <a:ext cx="796480" cy="2629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TextBox 57"/>
          <p:cNvSpPr txBox="1"/>
          <p:nvPr/>
        </p:nvSpPr>
        <p:spPr>
          <a:xfrm>
            <a:off x="2242736" y="2295151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DH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tangle 58"/>
          <p:cNvSpPr/>
          <p:nvPr/>
        </p:nvSpPr>
        <p:spPr>
          <a:xfrm>
            <a:off x="3797569" y="2437847"/>
            <a:ext cx="832752" cy="2185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TextBox 67"/>
          <p:cNvSpPr txBox="1"/>
          <p:nvPr/>
        </p:nvSpPr>
        <p:spPr>
          <a:xfrm>
            <a:off x="1925742" y="4269419"/>
            <a:ext cx="9714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AM210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Rectangle 68"/>
          <p:cNvSpPr/>
          <p:nvPr/>
        </p:nvSpPr>
        <p:spPr>
          <a:xfrm>
            <a:off x="2897226" y="4076837"/>
            <a:ext cx="870030" cy="57704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TextBox 73"/>
          <p:cNvSpPr txBox="1"/>
          <p:nvPr/>
        </p:nvSpPr>
        <p:spPr>
          <a:xfrm>
            <a:off x="2075889" y="3341681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Rectangle 74"/>
          <p:cNvSpPr/>
          <p:nvPr/>
        </p:nvSpPr>
        <p:spPr>
          <a:xfrm>
            <a:off x="2983326" y="3329410"/>
            <a:ext cx="927020" cy="2957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TextBox 75"/>
          <p:cNvSpPr txBox="1"/>
          <p:nvPr/>
        </p:nvSpPr>
        <p:spPr>
          <a:xfrm>
            <a:off x="6211236" y="326653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Rectangle 77"/>
          <p:cNvSpPr/>
          <p:nvPr/>
        </p:nvSpPr>
        <p:spPr>
          <a:xfrm>
            <a:off x="8674292" y="5296642"/>
            <a:ext cx="730409" cy="3314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TextBox 78"/>
          <p:cNvSpPr txBox="1"/>
          <p:nvPr/>
        </p:nvSpPr>
        <p:spPr>
          <a:xfrm>
            <a:off x="6737303" y="5256758"/>
            <a:ext cx="9276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T-ATP6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Rectangle 81"/>
          <p:cNvSpPr/>
          <p:nvPr/>
        </p:nvSpPr>
        <p:spPr>
          <a:xfrm>
            <a:off x="8560846" y="4357213"/>
            <a:ext cx="875435" cy="3314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TextBox 82"/>
          <p:cNvSpPr txBox="1"/>
          <p:nvPr/>
        </p:nvSpPr>
        <p:spPr>
          <a:xfrm>
            <a:off x="6870388" y="4287293"/>
            <a:ext cx="7403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TP5B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7821524" y="145977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7830950" y="111285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Straight Connector 22"/>
          <p:cNvCxnSpPr/>
          <p:nvPr/>
        </p:nvCxnSpPr>
        <p:spPr>
          <a:xfrm>
            <a:off x="6089437" y="3416632"/>
            <a:ext cx="15082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4" name="Group 23"/>
          <p:cNvGrpSpPr/>
          <p:nvPr/>
        </p:nvGrpSpPr>
        <p:grpSpPr>
          <a:xfrm>
            <a:off x="3405427" y="6143471"/>
            <a:ext cx="1384700" cy="577048"/>
            <a:chOff x="1973246" y="6247620"/>
            <a:chExt cx="1384700" cy="577048"/>
          </a:xfrm>
        </p:grpSpPr>
        <p:sp>
          <p:nvSpPr>
            <p:cNvPr id="85" name="TextBox 84"/>
            <p:cNvSpPr txBox="1"/>
            <p:nvPr/>
          </p:nvSpPr>
          <p:spPr>
            <a:xfrm>
              <a:off x="1973246" y="6415835"/>
              <a:ext cx="4964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 rot="21533104">
              <a:off x="2413263" y="6298459"/>
              <a:ext cx="93968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am210a</a:t>
              </a:r>
            </a:p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E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Rectangle 86"/>
            <p:cNvSpPr/>
            <p:nvPr/>
          </p:nvSpPr>
          <p:spPr>
            <a:xfrm>
              <a:off x="2034634" y="6247620"/>
              <a:ext cx="1323312" cy="57704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88" name="TextBox 87"/>
          <p:cNvSpPr txBox="1"/>
          <p:nvPr/>
        </p:nvSpPr>
        <p:spPr>
          <a:xfrm rot="21533104">
            <a:off x="2078749" y="6325462"/>
            <a:ext cx="1418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ample loading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24"/>
          <p:cNvSpPr txBox="1"/>
          <p:nvPr/>
        </p:nvSpPr>
        <p:spPr>
          <a:xfrm>
            <a:off x="5115696" y="162712"/>
            <a:ext cx="16879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7G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45992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7</TotalTime>
  <Words>156</Words>
  <Application>Microsoft Office PowerPoint</Application>
  <PresentationFormat>Widescreen</PresentationFormat>
  <Paragraphs>12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R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u, Jiangbin</dc:creator>
  <cp:lastModifiedBy>Wu, Jiangbin</cp:lastModifiedBy>
  <cp:revision>39</cp:revision>
  <dcterms:created xsi:type="dcterms:W3CDTF">2020-10-20T18:29:31Z</dcterms:created>
  <dcterms:modified xsi:type="dcterms:W3CDTF">2020-10-29T16:16:05Z</dcterms:modified>
</cp:coreProperties>
</file>